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3" r:id="rId2"/>
    <p:sldId id="256" r:id="rId3"/>
    <p:sldId id="262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3" d="100"/>
          <a:sy n="63" d="100"/>
        </p:scale>
        <p:origin x="764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2FFA31-1B7A-1484-E716-AC285764893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47A58F2-5308-1A9F-7672-D8FFC33B3B8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414F83-B9B8-E595-AA4B-9C5E04B3BF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AA14A3-623E-444A-8BE2-4F2B9B50C761}" type="datetimeFigureOut">
              <a:rPr lang="en-US" smtClean="0"/>
              <a:t>7/1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469379-6916-5D1A-E35B-BB9D8405A9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2A2CE6-A0CD-FBC3-7954-E987CA55D3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AB4BB-090A-4049-B4EF-B20A9EBE0F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42191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C14F5D-AEC9-67C5-DB82-FE435EA87C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43D976F-EFF3-B297-C22F-7E32DE6BD0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F26D65-65F5-F222-2B22-9DB5E2C566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AA14A3-623E-444A-8BE2-4F2B9B50C761}" type="datetimeFigureOut">
              <a:rPr lang="en-US" smtClean="0"/>
              <a:t>7/1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7163B4-6743-0C18-1AF9-0818BB1B4B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044B1B-EA80-7C35-D78C-98DC043288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AB4BB-090A-4049-B4EF-B20A9EBE0F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45189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434601B-422D-F675-3BC2-147B911D6BB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94573EF-D4AC-8C3E-8852-C03CC2608F7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60BFDB-15C5-9ABC-428D-4953DC7A19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AA14A3-623E-444A-8BE2-4F2B9B50C761}" type="datetimeFigureOut">
              <a:rPr lang="en-US" smtClean="0"/>
              <a:t>7/1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503E88-126F-86C6-D8AE-998A56B895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3ACA24-C9E7-3AAB-16CF-3A8D685EE4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AB4BB-090A-4049-B4EF-B20A9EBE0F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85642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810DCE-4CFC-39C8-E090-0BC4176118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FF024AD-B22D-B7B9-EA1B-9C86F697713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79370EA-AC01-9939-1AAC-667F1B972B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AA14A3-623E-444A-8BE2-4F2B9B50C761}" type="datetimeFigureOut">
              <a:rPr lang="en-US" smtClean="0"/>
              <a:t>7/1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D766EE-E31F-8A42-8188-4B0248BF6D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69B377-3014-2A0B-65FC-C0CB6693F7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AB4BB-090A-4049-B4EF-B20A9EBE0F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58322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D22766-20EE-E7D9-4BE4-77685F451D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2BE077E-9321-74AF-D471-9C770A45DC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A328CC-6CB3-053E-0CA0-DA0D23C385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AA14A3-623E-444A-8BE2-4F2B9B50C761}" type="datetimeFigureOut">
              <a:rPr lang="en-US" smtClean="0"/>
              <a:t>7/1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D06077-D25E-9788-EED6-381C4307C1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6D20BE0-B2F3-87EE-C433-517B763893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AB4BB-090A-4049-B4EF-B20A9EBE0F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70404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6D2362-61AB-399B-91FF-DEC7AE8F3D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9C667C8-BD21-9AED-69BA-FE1DC132BCF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61A7685-7C0C-45D8-B7B4-53FEE336475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56EEEEA-971D-6655-29FA-5951AE52E5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AA14A3-623E-444A-8BE2-4F2B9B50C761}" type="datetimeFigureOut">
              <a:rPr lang="en-US" smtClean="0"/>
              <a:t>7/16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4FBDBAA-3E62-9876-17FF-05A18997F2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C1BB8F5-4914-F0E8-ABD4-3E239FB76F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AB4BB-090A-4049-B4EF-B20A9EBE0F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55399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BD20A6-CD5D-5B56-CD1C-9533B7CC13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C0D819C-1FCD-BB5C-6460-1967B76A5D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CA46FD7-A09C-C177-CE60-D5A1522C251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D3CA521-B94C-F5E7-D799-B54CA16562F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CDD39DF-8423-998B-C125-2397A3FFE0C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D9B59E0-EA2A-AE8B-60E0-1BEA021826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AA14A3-623E-444A-8BE2-4F2B9B50C761}" type="datetimeFigureOut">
              <a:rPr lang="en-US" smtClean="0"/>
              <a:t>7/16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DDDB076-66AD-EBB3-FE9B-89B7AF9F62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153E5C6-9AA7-E61D-A9AB-4A1EB11602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AB4BB-090A-4049-B4EF-B20A9EBE0F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91435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1262B3-BEA2-9252-F801-2CA4B7B95A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A46308B-0ED6-8580-0F88-03EF86ED43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AA14A3-623E-444A-8BE2-4F2B9B50C761}" type="datetimeFigureOut">
              <a:rPr lang="en-US" smtClean="0"/>
              <a:t>7/16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D9D65B7-4DC5-C30E-9B05-C3DFCCC1E1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00352D6-BEBC-4913-9DD9-1BE40AF5C5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AB4BB-090A-4049-B4EF-B20A9EBE0F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81665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F7E6A62-7ED9-5C3A-772D-43988EA24A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AA14A3-623E-444A-8BE2-4F2B9B50C761}" type="datetimeFigureOut">
              <a:rPr lang="en-US" smtClean="0"/>
              <a:t>7/16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93D821F-1E27-B804-8A1C-43D3FD986A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AB7F05A-D87C-09A5-487D-A29C3D9206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AB4BB-090A-4049-B4EF-B20A9EBE0F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30387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D76D64-A0D3-B9FF-2CF9-B3659F62FC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0A1C87-B8BB-D724-5C16-AD147AFF8C7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88BE8FA-0BFD-820F-7ADE-5B3879E9DD9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10EA142-1DFE-F621-2535-BE0A2AB520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AA14A3-623E-444A-8BE2-4F2B9B50C761}" type="datetimeFigureOut">
              <a:rPr lang="en-US" smtClean="0"/>
              <a:t>7/16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8BB94E2-F2A9-BF9C-8054-B8CD12D3C1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F560131-03A1-4FCF-C6CA-7098847C54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AB4BB-090A-4049-B4EF-B20A9EBE0F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59519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9FCE02-80B6-C7F6-6AD7-8D83D3059F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54772F3-CBF8-43AB-508F-DED23F08DE2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128C98F-3693-73BF-933A-1AFD68C7A01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965C8D7-3110-1FF3-0E56-85289F3C43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AA14A3-623E-444A-8BE2-4F2B9B50C761}" type="datetimeFigureOut">
              <a:rPr lang="en-US" smtClean="0"/>
              <a:t>7/16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B98E1B4-FE3C-D0F7-D536-7B1F3D1514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057A351-A361-295F-A18C-3610B59BC5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9AB4BB-090A-4049-B4EF-B20A9EBE0F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336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A4BD78D-8C6C-DB4C-ECF9-8D56968911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D749EBF-948F-3C67-8C83-0E397C9F2F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7A13A4-9B55-3C98-B1D2-05FFD98DC75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AA14A3-623E-444A-8BE2-4F2B9B50C761}" type="datetimeFigureOut">
              <a:rPr lang="en-US" smtClean="0"/>
              <a:t>7/1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435FEA-6001-155C-0E1C-A340FBE1CA7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A24A2A-A78D-005F-A045-C895E7234AB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9AB4BB-090A-4049-B4EF-B20A9EBE0F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81196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close-up of a graph&#10;&#10;Description automatically generated">
            <a:extLst>
              <a:ext uri="{FF2B5EF4-FFF2-40B4-BE49-F238E27FC236}">
                <a16:creationId xmlns:a16="http://schemas.microsoft.com/office/drawing/2014/main" id="{D9B821C5-632E-4477-536B-04A0A70C8A3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4290" y="0"/>
            <a:ext cx="11503420" cy="68580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578BBC82-7605-AF77-62A8-8AD175F7AD85}"/>
              </a:ext>
            </a:extLst>
          </p:cNvPr>
          <p:cNvSpPr txBox="1"/>
          <p:nvPr/>
        </p:nvSpPr>
        <p:spPr>
          <a:xfrm>
            <a:off x="2567031" y="5972961"/>
            <a:ext cx="69245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Supplemental Figure 1</a:t>
            </a:r>
            <a:r>
              <a:rPr lang="en-US" sz="1200" dirty="0"/>
              <a:t>: Grade ≥ 3 anemia in 4- vs 3-drug induction regimens in our meta-analysis population</a:t>
            </a:r>
          </a:p>
        </p:txBody>
      </p:sp>
    </p:spTree>
    <p:extLst>
      <p:ext uri="{BB962C8B-B14F-4D97-AF65-F5344CB8AC3E}">
        <p14:creationId xmlns:p14="http://schemas.microsoft.com/office/powerpoint/2010/main" val="14516460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close-up of a chart&#10;&#10;Description automatically generated">
            <a:extLst>
              <a:ext uri="{FF2B5EF4-FFF2-40B4-BE49-F238E27FC236}">
                <a16:creationId xmlns:a16="http://schemas.microsoft.com/office/drawing/2014/main" id="{3810789C-C79D-E6C5-3E5D-9D9BE2EB3D2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4290" y="0"/>
            <a:ext cx="11503420" cy="68580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29CDA56-6177-93E4-FB80-536FC82C939F}"/>
              </a:ext>
            </a:extLst>
          </p:cNvPr>
          <p:cNvSpPr txBox="1"/>
          <p:nvPr/>
        </p:nvSpPr>
        <p:spPr>
          <a:xfrm>
            <a:off x="2567031" y="5972961"/>
            <a:ext cx="71506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Supplemental Figure 2</a:t>
            </a:r>
            <a:r>
              <a:rPr lang="en-US" sz="1200" dirty="0"/>
              <a:t>: Grade ≥ 3 neuropathy in 4- vs 3-drug induction regimens in our meta-analysis population</a:t>
            </a:r>
          </a:p>
        </p:txBody>
      </p:sp>
    </p:spTree>
    <p:extLst>
      <p:ext uri="{BB962C8B-B14F-4D97-AF65-F5344CB8AC3E}">
        <p14:creationId xmlns:p14="http://schemas.microsoft.com/office/powerpoint/2010/main" val="13523662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close-up of a graph&#10;&#10;Description automatically generated">
            <a:extLst>
              <a:ext uri="{FF2B5EF4-FFF2-40B4-BE49-F238E27FC236}">
                <a16:creationId xmlns:a16="http://schemas.microsoft.com/office/drawing/2014/main" id="{74645C10-27E6-05B4-AD4F-B3F01A727AA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4290" y="0"/>
            <a:ext cx="11503420" cy="68580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1B4C9706-51B2-DC38-5302-4491521F13E2}"/>
              </a:ext>
            </a:extLst>
          </p:cNvPr>
          <p:cNvSpPr txBox="1"/>
          <p:nvPr/>
        </p:nvSpPr>
        <p:spPr>
          <a:xfrm>
            <a:off x="2441196" y="5645791"/>
            <a:ext cx="72090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Supplemental Figure 3</a:t>
            </a:r>
            <a:r>
              <a:rPr lang="en-US" sz="1200" dirty="0"/>
              <a:t>: Grade ≥ 3 pneumonia in 4- vs 3-drug induction regimens in our meta-analysis population</a:t>
            </a:r>
          </a:p>
        </p:txBody>
      </p:sp>
    </p:spTree>
    <p:extLst>
      <p:ext uri="{BB962C8B-B14F-4D97-AF65-F5344CB8AC3E}">
        <p14:creationId xmlns:p14="http://schemas.microsoft.com/office/powerpoint/2010/main" val="15338842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54</Words>
  <Application>Microsoft Office PowerPoint</Application>
  <PresentationFormat>Widescreen</PresentationFormat>
  <Paragraphs>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ul, Barry A</dc:creator>
  <cp:lastModifiedBy>Megan Taylor</cp:lastModifiedBy>
  <cp:revision>1</cp:revision>
  <dcterms:created xsi:type="dcterms:W3CDTF">2024-02-27T18:08:32Z</dcterms:created>
  <dcterms:modified xsi:type="dcterms:W3CDTF">2024-07-16T15:38:47Z</dcterms:modified>
</cp:coreProperties>
</file>